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ct" ContentType="image/x-pi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52560" y="685440"/>
            <a:ext cx="495288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579C60-6F7A-4BCC-92E5-2E612BE48C47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5888A6-93F4-484F-AA6A-A51728008F58}" type="slidenum">
              <a:rPr b="0" lang="pt-B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1"/>
          <p:cNvSpPr>
            <a:spLocks noGrp="1"/>
          </p:cNvSpPr>
          <p:nvPr>
            <p:ph type="sldImg"/>
          </p:nvPr>
        </p:nvSpPr>
        <p:spPr>
          <a:xfrm>
            <a:off x="954000" y="685800"/>
            <a:ext cx="4951440" cy="3429000"/>
          </a:xfrm>
          <a:prstGeom prst="rect">
            <a:avLst/>
          </a:prstGeom>
          <a:ln w="0">
            <a:noFill/>
          </a:ln>
        </p:spPr>
      </p:sp>
      <p:sp>
        <p:nvSpPr>
          <p:cNvPr id="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B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40897-7515-4EBD-A27F-A0D959E9E2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AB960-9ADE-4578-AD11-3341ACF626E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6DD0C-B36A-4D1E-90C0-176C0790C3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5A9B4-6DD6-4DCA-A024-265EB2B60B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75C00-C2CF-4073-8501-2DEC99500A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F76F1A-EBBF-464D-B6B2-15378582ED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3350F-A2C4-45FB-AB5A-CEB9E9D7B2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EF1D03-3D2F-4A42-9D37-A95846F228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3DC42-80D7-49FB-A259-27E9C2E2DC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9C3E24-1D90-4E6F-B683-C25EBF9532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427E2-3516-4A28-92D2-D382381279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FA8A09-759F-4C1B-A6F5-204E0CA0BE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244920"/>
            <a:ext cx="231120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244920"/>
            <a:ext cx="313668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244920"/>
            <a:ext cx="231156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B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0C0DC2-61C8-41D5-9010-9B8C4E40B2D9}" type="slidenum">
              <a:rPr b="0" lang="pt-B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CaixaDeTexto 45"/>
          <p:cNvSpPr/>
          <p:nvPr/>
        </p:nvSpPr>
        <p:spPr>
          <a:xfrm>
            <a:off x="1954080" y="163440"/>
            <a:ext cx="91764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  <a:ea typeface="Arial"/>
              </a:rPr>
              <a:t>TIRs Class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CaixaDeTexto 46"/>
          <p:cNvSpPr/>
          <p:nvPr/>
        </p:nvSpPr>
        <p:spPr>
          <a:xfrm>
            <a:off x="6788880" y="163440"/>
            <a:ext cx="96012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  <a:ea typeface="Arial"/>
              </a:rPr>
              <a:t>TIRs ClassI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ixaDeTexto 47"/>
          <p:cNvSpPr/>
          <p:nvPr/>
        </p:nvSpPr>
        <p:spPr>
          <a:xfrm>
            <a:off x="1507680" y="3701880"/>
            <a:ext cx="1696320" cy="43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  <a:ea typeface="Arial"/>
              </a:rPr>
              <a:t>Avarage identity  0.78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aixaDeTexto 48"/>
          <p:cNvSpPr/>
          <p:nvPr/>
        </p:nvSpPr>
        <p:spPr>
          <a:xfrm>
            <a:off x="6689160" y="3727440"/>
            <a:ext cx="1696320" cy="43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200" spc="-1" strike="noStrike">
                <a:solidFill>
                  <a:srgbClr val="000000"/>
                </a:solidFill>
                <a:latin typeface="Arial"/>
                <a:ea typeface="Arial"/>
              </a:rPr>
              <a:t>Avarage identity  0.74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aixaDeTexto 49"/>
          <p:cNvSpPr/>
          <p:nvPr/>
        </p:nvSpPr>
        <p:spPr>
          <a:xfrm>
            <a:off x="1665720" y="5326200"/>
            <a:ext cx="1089720" cy="26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300" spc="-1" strike="noStrike">
                <a:solidFill>
                  <a:srgbClr val="000000"/>
                </a:solidFill>
                <a:latin typeface="Arial"/>
                <a:ea typeface="Arial"/>
              </a:rPr>
              <a:t>Exons ClassI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ixaDeTexto 50"/>
          <p:cNvSpPr/>
          <p:nvPr/>
        </p:nvSpPr>
        <p:spPr>
          <a:xfrm>
            <a:off x="7146000" y="5326200"/>
            <a:ext cx="1135440" cy="26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300" spc="-1" strike="noStrike">
                <a:solidFill>
                  <a:srgbClr val="000000"/>
                </a:solidFill>
                <a:latin typeface="Arial"/>
                <a:ea typeface="Arial"/>
              </a:rPr>
              <a:t>Exons ClassII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ixaDeTexto 51"/>
          <p:cNvSpPr/>
          <p:nvPr/>
        </p:nvSpPr>
        <p:spPr>
          <a:xfrm>
            <a:off x="1627560" y="4033800"/>
            <a:ext cx="1135440" cy="26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300" spc="-1" strike="noStrike">
                <a:solidFill>
                  <a:srgbClr val="000000"/>
                </a:solidFill>
                <a:latin typeface="Arial"/>
                <a:ea typeface="Arial"/>
              </a:rPr>
              <a:t>Introns ClassI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ixaDeTexto 52"/>
          <p:cNvSpPr/>
          <p:nvPr/>
        </p:nvSpPr>
        <p:spPr>
          <a:xfrm>
            <a:off x="6825240" y="4038480"/>
            <a:ext cx="1181160" cy="263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64440" rIns="64440" tIns="32400" bIns="324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300" spc="-1" strike="noStrike">
                <a:solidFill>
                  <a:srgbClr val="000000"/>
                </a:solidFill>
                <a:latin typeface="Arial"/>
                <a:ea typeface="Arial"/>
              </a:rPr>
              <a:t>Introns ClassII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233280" y="4384800"/>
          <a:ext cx="4162680" cy="803160"/>
        </p:xfrm>
        <a:graphic>
          <a:graphicData uri="http://schemas.openxmlformats.org/drawingml/2006/table">
            <a:tbl>
              <a:tblPr/>
              <a:tblGrid>
                <a:gridCol w="1040040"/>
                <a:gridCol w="1041120"/>
                <a:gridCol w="1040040"/>
                <a:gridCol w="1041480"/>
              </a:tblGrid>
              <a:tr h="2016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86_H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5_J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69_M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86_H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5_J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160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69_M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7" name=""/>
          <p:cNvGraphicFramePr/>
          <p:nvPr/>
        </p:nvGraphicFramePr>
        <p:xfrm>
          <a:off x="233280" y="5641920"/>
          <a:ext cx="4127760" cy="784440"/>
        </p:xfrm>
        <a:graphic>
          <a:graphicData uri="http://schemas.openxmlformats.org/drawingml/2006/table">
            <a:tbl>
              <a:tblPr/>
              <a:tblGrid>
                <a:gridCol w="1032120"/>
                <a:gridCol w="1031760"/>
                <a:gridCol w="1031760"/>
                <a:gridCol w="1032120"/>
              </a:tblGrid>
              <a:tr h="196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86_H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5_J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69_M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86_H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5_J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6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69_M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8" name=""/>
          <p:cNvGraphicFramePr/>
          <p:nvPr/>
        </p:nvGraphicFramePr>
        <p:xfrm>
          <a:off x="5546880" y="4443480"/>
          <a:ext cx="4127400" cy="784080"/>
        </p:xfrm>
        <a:graphic>
          <a:graphicData uri="http://schemas.openxmlformats.org/drawingml/2006/table">
            <a:tbl>
              <a:tblPr/>
              <a:tblGrid>
                <a:gridCol w="1031760"/>
                <a:gridCol w="1031760"/>
                <a:gridCol w="1032120"/>
                <a:gridCol w="1031760"/>
              </a:tblGrid>
              <a:tr h="196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4_G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1_A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07_O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4_G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6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1_A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07_O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8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9" name=""/>
          <p:cNvGraphicFramePr/>
          <p:nvPr/>
        </p:nvGraphicFramePr>
        <p:xfrm>
          <a:off x="5537160" y="5641920"/>
          <a:ext cx="4127400" cy="784440"/>
        </p:xfrm>
        <a:graphic>
          <a:graphicData uri="http://schemas.openxmlformats.org/drawingml/2006/table">
            <a:tbl>
              <a:tblPr/>
              <a:tblGrid>
                <a:gridCol w="1031760"/>
                <a:gridCol w="1032120"/>
                <a:gridCol w="1031760"/>
                <a:gridCol w="1031760"/>
              </a:tblGrid>
              <a:tr h="196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4_G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1_A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07_O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1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04_G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548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01_A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pt-BR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692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07_O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0" name="Retângulo 57"/>
          <p:cNvSpPr/>
          <p:nvPr/>
        </p:nvSpPr>
        <p:spPr>
          <a:xfrm>
            <a:off x="231840" y="495360"/>
            <a:ext cx="4568760" cy="27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4440" rIns="64440" tIns="32400" bIns="324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5’   --ATTGTGCCATCATGAAAACTGGGCTTCGCAATTTTGCCATCTCGAAAATGGGATTCGC 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3’   CAATTGTGCCATTATGAAAATTGGGCTTCATAATTTTGTCATCCCGAAAATAGGATTCGA 6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15_J16_TIR5’   --ATTCTGCCATTATGAAAACTGGGCTTCGCAATTTTGCCATCCCGTAAATGGGATTCGC 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 ****** ******* ********  ******* **** ** **** *******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5’   TCGTTTGCCATTCTCAAACGATACGTACCCGCAAATATGCCCTACGAAGAATTTGTCTTC 1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3’   TCGTTTACCATTCTCAAACGATACACACCAGCAAATATGCCCTGGGAAGAATTTGTCTTC 1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15_J16_TIR5’   CCGTTTGCCATTCTCAAACGATACACACCCGCAAATATGCCCTGTGGAGGATTTGTTGCC 1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** *****************  *** *************  * ** ******   *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5’   AAATTTATTTATTTTTTTGCCATGACATATTTGCCTTCCAGTTTTGCCCCTGGCTTGATT 17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3’   AAATTTAAT--TTTTTTTGCCATGGCATATTTGCCTTCCAATTTTTCCCCTGCCCTGATT 17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15_J16_TIR5’   AAATTAATT--TTTTTTTACCATGGCAAACTTGCCTTCCCGTTTTGCCCCT-CCCTGATG 17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** * *  ******* ***** ** * *********  **** *****  * ****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5’   CCATCTTT---CCT--CT-TCAT-------TCACCGTCGTTCACGGAGACAGACGACA-C 22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3’   CCATCTTT---CCT--CT-TCAT-------TCACCGTCGTTCACGGAGACAGATGACA-C 22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15_J16_TIR5’   CCATCATGGAGCCTTTCAGTCACGGGTGATTCACGGTCGTTCTCTTGGACGGGAGACAGA 23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** *    ***  *  ***     **** ******* *   *** *  **** 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5’   AGACGAGAGAGAACGGAGTGACGCCGCTAGGTCAGGCGAGGGAGAGAGGGAAGGGAGATC 28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3’   AGACGAGAGAGAACGGAGCGACGCCGCTAAGTCAGGTGAGGGAGAGAGGGAAGGAAGATC 28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15_J16_TIR5’   CGACGCTCGTCTTCATA-TGACGTCGCTAGGTCAAGCGAGGAAGAGAGGGAACGGCTCCC 29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*   *    *  *  **** ***** **** * **** ********** *     *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5’   TTGAGGGAAGGGCTCC-CCGCCGCCG---CCGCCGCCGACGATC 32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86_H20_TIR3’   TGGAGGGTAGGGCTCG-CCGCCTCCGATGCCGCCACCGACGGTC 32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15_J16_TIR5’   CGCCGCCGCCAGCACCGTCGCCTCCGCCGCCGCCGCCGACGGTC 33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   ** *   **** ***   ***** ****** **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tângulo 58"/>
          <p:cNvSpPr/>
          <p:nvPr/>
        </p:nvSpPr>
        <p:spPr>
          <a:xfrm>
            <a:off x="5091120" y="469800"/>
            <a:ext cx="4600440" cy="317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64440" rIns="64440" tIns="32400" bIns="324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5’   GGTCCCGTCTTTTTTTTTGGCCCCTTTTTG--AAAGATTCTCTCAAATATGCCCCTGGTC 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3’   --TTTTTTTTGTTTTTTTTGCCCCTTTTTTTTAAAGATTCTCTCAAATATGTCCCTGGCC 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04-G22_TIR3’   -GGTCGGCCGTCTTTTTTAGCCCTTTTTTCG-AAAGATTCTCTCAAATATGTCCCTGGTG 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5’   -CGTCTTTTTTGTTTTTTGGCCCTTTTTTTG-AAAGATTCTCTCAAATAGGCCCCTGACG 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3’   -CGTCTTTTTTGTTTTTTGGCCCTTTTTTTG-AAAGATTCTCTCAAATAGGCCCCTGACG 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*** **** *****   ***************** * *****  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5’   GAAATATTTCAAAAAAAATGAACCTTGATCTTGACGCCACAGTCACCGGCGCCAAGATAT 1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3’   GAAATATTTCAAAAAATAG--ACCCTGATCTTGGCGCCATAATCACCGGCGCCAAGATAT 1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04-G22_TIR3’   GAAAGATTTCAAAAAATAG--ATCCTTATCTTGGCGCCATAGTCGTCGACGCCAAGATAT 1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5’   GAAAGATTTCAAAAAATGG--ACCCTCAGCTTGGCGCCATGGTCCATGGCGCCAAGCTAC 1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3’   GAAAGATTTCAAAAAATGG--ACCCTCAGCTTGGCGCCATGGTCCATGGCGCCAAGCTAC 1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* ***********     * * * * **** *****   **   * ******* **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5’   AAGGGCATGACGCCATTCTCACTGACGCCATGGCCCTGCTGGCGTGGCGCT--------- 16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3’   AAGGGCATGGCGCCATTCTCACTGGCGTCATGGCCCTGTTGGCGTGGCGCT--------- 1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04-G22_TIR3’   AACGGCATGGCGCCATGGTCACTGGCGCCATGACCCTGCCGTCGTGGCGCT--------- 1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5’   AACGTCATGGCGCCATGTATCCTGGCGCCAAGAGGCATCCGACGTGGCTACACGGGGATC 17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3’   AACGTCATGGCGCCATGTATCCTGGCGCCAAGAGGCATCCGACGTGGCTCCACGGGAATC 17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 * **** ******     *** ** ** *   *    * ******     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5’   TACGTGG-AAGGGGTCTTGGCGCCACAG--------ATCTTGGCGCCA------------ 20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3’   TACGTGA-AAGGGGTCTTGGCGCCATAG--------ATCTTGGCGCCAGCCCCATTGGTG 2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04-G22_TIR3’   GACGTGG-CAGGGAGCATGGCGCCATGG--------ATCTTGGCGCCA------------ 20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5’   TACGTGGCGCGTAGGCTTGGCGCCAAGATCCGTAATATCCTGGCGCCA------------ 22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3’   TACGTG--GCGTAG-CTTGGTGCCATGG--------AGCATGGCGCCA------------ 2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****    *    * *** ****        * * ********     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5’   ---AGCCTTGGCGCCACA-TACTCGACGCCAAGC 23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201-A23_TIR3’   TCATGCCTTGGCGCCACAGATCTTGGCGCCAAGC 25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104-G22_TIR3’   ----AGCATGGCGCCATGGATCTTGGCGCCAAGC 23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5’   ---AGCCTTGGCGCCACGGATCTTGGCGCCAAGC 25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007-O13_TIR3’   ---AGACTTGGCGCCAAGATCCATGGCGCCAAGC 24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                      </a:t>
            </a:r>
            <a:r>
              <a:rPr b="1" lang="en-US" sz="600" spc="-1" strike="noStrike">
                <a:solidFill>
                  <a:srgbClr val="000000"/>
                </a:solidFill>
                <a:latin typeface="Courier New"/>
                <a:ea typeface="Courier New"/>
              </a:rPr>
              <a:t>* ********     *  * ********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15"/>
          <p:cNvSpPr/>
          <p:nvPr/>
        </p:nvSpPr>
        <p:spPr>
          <a:xfrm>
            <a:off x="152640" y="10152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1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3" name=""/>
          <p:cNvGraphicFramePr/>
          <p:nvPr/>
        </p:nvGraphicFramePr>
        <p:xfrm>
          <a:off x="1219320" y="1866960"/>
          <a:ext cx="7737480" cy="37386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64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19320" y="1866960"/>
                    <a:ext cx="7737480" cy="3738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5" name="AutoShape 3"/>
          <p:cNvSpPr/>
          <p:nvPr/>
        </p:nvSpPr>
        <p:spPr>
          <a:xfrm rot="16200000">
            <a:off x="2543040" y="1044360"/>
            <a:ext cx="39600" cy="1366920"/>
          </a:xfrm>
          <a:custGeom>
            <a:avLst/>
            <a:gdLst>
              <a:gd name="textAreaLeft" fmla="*/ 0 w 39600"/>
              <a:gd name="textAreaRight" fmla="*/ 27720 w 39600"/>
              <a:gd name="textAreaTop" fmla="*/ 56880 h 1366920"/>
              <a:gd name="textAreaBottom" fmla="*/ 1310040 h 1366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4"/>
          <p:cNvSpPr/>
          <p:nvPr/>
        </p:nvSpPr>
        <p:spPr>
          <a:xfrm rot="16200000">
            <a:off x="4028400" y="1118520"/>
            <a:ext cx="47520" cy="1201680"/>
          </a:xfrm>
          <a:custGeom>
            <a:avLst/>
            <a:gdLst>
              <a:gd name="textAreaLeft" fmla="*/ 0 w 47520"/>
              <a:gd name="textAreaRight" fmla="*/ 33480 w 47520"/>
              <a:gd name="textAreaTop" fmla="*/ 50040 h 1201680"/>
              <a:gd name="textAreaBottom" fmla="*/ 1151640 h 12016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AutoShape 5"/>
          <p:cNvSpPr/>
          <p:nvPr/>
        </p:nvSpPr>
        <p:spPr>
          <a:xfrm rot="16200000">
            <a:off x="5690520" y="770760"/>
            <a:ext cx="47520" cy="1881360"/>
          </a:xfrm>
          <a:custGeom>
            <a:avLst/>
            <a:gdLst>
              <a:gd name="textAreaLeft" fmla="*/ 0 w 47520"/>
              <a:gd name="textAreaRight" fmla="*/ 33480 w 47520"/>
              <a:gd name="textAreaTop" fmla="*/ 78120 h 1881360"/>
              <a:gd name="textAreaBottom" fmla="*/ 1803240 h 1881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6"/>
          <p:cNvSpPr/>
          <p:nvPr/>
        </p:nvSpPr>
        <p:spPr>
          <a:xfrm rot="16200000">
            <a:off x="7729560" y="771480"/>
            <a:ext cx="46080" cy="1881360"/>
          </a:xfrm>
          <a:custGeom>
            <a:avLst/>
            <a:gdLst>
              <a:gd name="textAreaLeft" fmla="*/ 0 w 46080"/>
              <a:gd name="textAreaRight" fmla="*/ 32400 w 46080"/>
              <a:gd name="textAreaTop" fmla="*/ 78120 h 1881360"/>
              <a:gd name="textAreaBottom" fmla="*/ 1803240 h 1881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10800" y="0"/>
                  <a:pt x="21600" y="900"/>
                  <a:pt x="21600" y="1800"/>
                </a:cubicBezTo>
                <a:lnTo>
                  <a:pt x="21600" y="19800"/>
                </a:lnTo>
                <a:cubicBezTo>
                  <a:pt x="21600" y="20700"/>
                  <a:pt x="108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7"/>
          <p:cNvSpPr/>
          <p:nvPr/>
        </p:nvSpPr>
        <p:spPr>
          <a:xfrm>
            <a:off x="1979640" y="777960"/>
            <a:ext cx="11408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  <a:ea typeface="Courier New"/>
              </a:rPr>
              <a:t>BAC095F0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Courier New"/>
                <a:ea typeface="Courier New"/>
              </a:rPr>
              <a:t>BAC148J0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8"/>
          <p:cNvSpPr/>
          <p:nvPr/>
        </p:nvSpPr>
        <p:spPr>
          <a:xfrm>
            <a:off x="3495960" y="935640"/>
            <a:ext cx="114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  <a:ea typeface="Courier New"/>
              </a:rPr>
              <a:t>BAC115J1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9"/>
          <p:cNvSpPr/>
          <p:nvPr/>
        </p:nvSpPr>
        <p:spPr>
          <a:xfrm>
            <a:off x="5204880" y="937080"/>
            <a:ext cx="114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  <a:ea typeface="Courier New"/>
              </a:rPr>
              <a:t>BAC086H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0"/>
          <p:cNvSpPr/>
          <p:nvPr/>
        </p:nvSpPr>
        <p:spPr>
          <a:xfrm>
            <a:off x="7216200" y="933840"/>
            <a:ext cx="114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ourier New"/>
                <a:ea typeface="Courier New"/>
              </a:rPr>
              <a:t>BAC249C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1"/>
          <p:cNvSpPr/>
          <p:nvPr/>
        </p:nvSpPr>
        <p:spPr>
          <a:xfrm>
            <a:off x="5364000" y="339408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2"/>
          <p:cNvSpPr/>
          <p:nvPr/>
        </p:nvSpPr>
        <p:spPr>
          <a:xfrm>
            <a:off x="6824520" y="337356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13"/>
          <p:cNvSpPr/>
          <p:nvPr/>
        </p:nvSpPr>
        <p:spPr>
          <a:xfrm>
            <a:off x="7869240" y="339084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4"/>
          <p:cNvSpPr/>
          <p:nvPr/>
        </p:nvSpPr>
        <p:spPr>
          <a:xfrm>
            <a:off x="8324640" y="339408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15"/>
          <p:cNvSpPr/>
          <p:nvPr/>
        </p:nvSpPr>
        <p:spPr>
          <a:xfrm>
            <a:off x="2107080" y="1332000"/>
            <a:ext cx="1415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Class I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16"/>
          <p:cNvSpPr/>
          <p:nvPr/>
        </p:nvSpPr>
        <p:spPr>
          <a:xfrm>
            <a:off x="3589560" y="1330200"/>
            <a:ext cx="114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Class 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17"/>
          <p:cNvSpPr/>
          <p:nvPr/>
        </p:nvSpPr>
        <p:spPr>
          <a:xfrm>
            <a:off x="5197680" y="1338120"/>
            <a:ext cx="1140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Class 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18"/>
          <p:cNvSpPr/>
          <p:nvPr/>
        </p:nvSpPr>
        <p:spPr>
          <a:xfrm>
            <a:off x="7278480" y="1328760"/>
            <a:ext cx="127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1800" spc="-1" strike="noStrike">
                <a:solidFill>
                  <a:srgbClr val="000000"/>
                </a:solidFill>
                <a:latin typeface="Courier New"/>
                <a:ea typeface="Courier New"/>
              </a:rPr>
              <a:t>Class IV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21"/>
          <p:cNvSpPr/>
          <p:nvPr/>
        </p:nvSpPr>
        <p:spPr>
          <a:xfrm rot="16200000">
            <a:off x="786600" y="2739240"/>
            <a:ext cx="654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BR" sz="1400" spc="-1" strike="noStrike">
                <a:solidFill>
                  <a:srgbClr val="000000"/>
                </a:solidFill>
                <a:latin typeface="Arial"/>
              </a:rPr>
              <a:t>ds/d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2"/>
          <p:cNvSpPr/>
          <p:nvPr/>
        </p:nvSpPr>
        <p:spPr>
          <a:xfrm>
            <a:off x="340920" y="309600"/>
            <a:ext cx="843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2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4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23T17:04:05Z</dcterms:created>
  <dc:creator>Marie-Anne &amp; Magda &amp; Guilherme</dc:creator>
  <dc:description/>
  <cp:keywords/>
  <dc:language>en-US</dc:language>
  <cp:lastModifiedBy>Marie-Anne Van Sluys</cp:lastModifiedBy>
  <dcterms:modified xsi:type="dcterms:W3CDTF">2012-04-24T19:00:46Z</dcterms:modified>
  <cp:revision>53</cp:revision>
  <dc:subject/>
  <dc:title>Slide 1</dc:title>
</cp:coreProperties>
</file>